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102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CCA15-506F-47C4-89FB-64648476CC2F}" type="datetimeFigureOut">
              <a:rPr lang="en-CA" smtClean="0"/>
              <a:t>2019-06-1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3C9171-3ABB-4903-ABD2-8B16A28A6D7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496123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CCA15-506F-47C4-89FB-64648476CC2F}" type="datetimeFigureOut">
              <a:rPr lang="en-CA" smtClean="0"/>
              <a:t>2019-06-1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3C9171-3ABB-4903-ABD2-8B16A28A6D7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325062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CCA15-506F-47C4-89FB-64648476CC2F}" type="datetimeFigureOut">
              <a:rPr lang="en-CA" smtClean="0"/>
              <a:t>2019-06-1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3C9171-3ABB-4903-ABD2-8B16A28A6D7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508674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CCA15-506F-47C4-89FB-64648476CC2F}" type="datetimeFigureOut">
              <a:rPr lang="en-CA" smtClean="0"/>
              <a:t>2019-06-1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3C9171-3ABB-4903-ABD2-8B16A28A6D7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238347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CCA15-506F-47C4-89FB-64648476CC2F}" type="datetimeFigureOut">
              <a:rPr lang="en-CA" smtClean="0"/>
              <a:t>2019-06-1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3C9171-3ABB-4903-ABD2-8B16A28A6D7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5621110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CCA15-506F-47C4-89FB-64648476CC2F}" type="datetimeFigureOut">
              <a:rPr lang="en-CA" smtClean="0"/>
              <a:t>2019-06-14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3C9171-3ABB-4903-ABD2-8B16A28A6D7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056412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CCA15-506F-47C4-89FB-64648476CC2F}" type="datetimeFigureOut">
              <a:rPr lang="en-CA" smtClean="0"/>
              <a:t>2019-06-14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3C9171-3ABB-4903-ABD2-8B16A28A6D7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916274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CCA15-506F-47C4-89FB-64648476CC2F}" type="datetimeFigureOut">
              <a:rPr lang="en-CA" smtClean="0"/>
              <a:t>2019-06-14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3C9171-3ABB-4903-ABD2-8B16A28A6D7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903667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CCA15-506F-47C4-89FB-64648476CC2F}" type="datetimeFigureOut">
              <a:rPr lang="en-CA" smtClean="0"/>
              <a:t>2019-06-14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3C9171-3ABB-4903-ABD2-8B16A28A6D7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193696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CCA15-506F-47C4-89FB-64648476CC2F}" type="datetimeFigureOut">
              <a:rPr lang="en-CA" smtClean="0"/>
              <a:t>2019-06-14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3C9171-3ABB-4903-ABD2-8B16A28A6D7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176444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CCA15-506F-47C4-89FB-64648476CC2F}" type="datetimeFigureOut">
              <a:rPr lang="en-CA" smtClean="0"/>
              <a:t>2019-06-14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3C9171-3ABB-4903-ABD2-8B16A28A6D7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259544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8CCA15-506F-47C4-89FB-64648476CC2F}" type="datetimeFigureOut">
              <a:rPr lang="en-CA" smtClean="0"/>
              <a:t>2019-06-1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3C9171-3ABB-4903-ABD2-8B16A28A6D7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335291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557654" y="903750"/>
            <a:ext cx="4640008" cy="4349643"/>
            <a:chOff x="1549617" y="889463"/>
            <a:chExt cx="4640008" cy="4349643"/>
          </a:xfrm>
        </p:grpSpPr>
        <p:pic>
          <p:nvPicPr>
            <p:cNvPr id="5" name="Picture 4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878" t="15303" r="18315"/>
            <a:stretch/>
          </p:blipFill>
          <p:spPr bwMode="auto">
            <a:xfrm>
              <a:off x="1986768" y="1470461"/>
              <a:ext cx="4034941" cy="37686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6" name="Parallelogram 5"/>
            <p:cNvSpPr/>
            <p:nvPr/>
          </p:nvSpPr>
          <p:spPr>
            <a:xfrm rot="18687942">
              <a:off x="1582878" y="1205215"/>
              <a:ext cx="1460051" cy="828548"/>
            </a:xfrm>
            <a:prstGeom prst="parallelogram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 sz="700"/>
            </a:p>
          </p:txBody>
        </p:sp>
        <p:sp>
          <p:nvSpPr>
            <p:cNvPr id="7" name="TextBox 6"/>
            <p:cNvSpPr txBox="1"/>
            <p:nvPr/>
          </p:nvSpPr>
          <p:spPr>
            <a:xfrm rot="182958">
              <a:off x="1549617" y="2022084"/>
              <a:ext cx="84985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700" dirty="0">
                  <a:latin typeface="Arial" panose="020B0604020202020204" pitchFamily="34" charset="0"/>
                  <a:cs typeface="Arial" panose="020B0604020202020204" pitchFamily="34" charset="0"/>
                </a:rPr>
                <a:t>NOS Terminator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 rot="266994">
              <a:off x="1677092" y="1807663"/>
              <a:ext cx="79329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700" dirty="0">
                  <a:latin typeface="Arial" panose="020B0604020202020204" pitchFamily="34" charset="0"/>
                  <a:cs typeface="Arial" panose="020B0604020202020204" pitchFamily="34" charset="0"/>
                </a:rPr>
                <a:t>TaU6 promoter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 rot="335373">
              <a:off x="2221246" y="1342816"/>
              <a:ext cx="82923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700" dirty="0">
                  <a:latin typeface="Arial" panose="020B0604020202020204" pitchFamily="34" charset="0"/>
                  <a:cs typeface="Arial" panose="020B0604020202020204" pitchFamily="34" charset="0"/>
                </a:rPr>
                <a:t>TaU6 promoter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 rot="316503">
              <a:off x="1967304" y="1630172"/>
              <a:ext cx="56137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7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gRNA-1</a:t>
              </a:r>
              <a:endParaRPr lang="en-CA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 rot="331915">
              <a:off x="1856150" y="1501451"/>
              <a:ext cx="94881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700" dirty="0">
                  <a:latin typeface="Arial" panose="020B0604020202020204" pitchFamily="34" charset="0"/>
                  <a:cs typeface="Arial" panose="020B0604020202020204" pitchFamily="34" charset="0"/>
                </a:rPr>
                <a:t>guide RNA scaffold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 rot="450911">
              <a:off x="2748244" y="1214832"/>
              <a:ext cx="56137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7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gRNA-2</a:t>
              </a:r>
              <a:endParaRPr lang="en-CA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 rot="515414">
              <a:off x="2814482" y="1104839"/>
              <a:ext cx="98686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700" dirty="0">
                  <a:latin typeface="Arial" panose="020B0604020202020204" pitchFamily="34" charset="0"/>
                  <a:cs typeface="Arial" panose="020B0604020202020204" pitchFamily="34" charset="0"/>
                </a:rPr>
                <a:t>guide RNA scaffold</a:t>
              </a:r>
            </a:p>
          </p:txBody>
        </p:sp>
        <p:cxnSp>
          <p:nvCxnSpPr>
            <p:cNvPr id="14" name="Straight Connector 13"/>
            <p:cNvCxnSpPr/>
            <p:nvPr/>
          </p:nvCxnSpPr>
          <p:spPr>
            <a:xfrm>
              <a:off x="3667948" y="1310983"/>
              <a:ext cx="151309" cy="197983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/>
            <p:cNvCxnSpPr/>
            <p:nvPr/>
          </p:nvCxnSpPr>
          <p:spPr>
            <a:xfrm>
              <a:off x="3456759" y="1398572"/>
              <a:ext cx="287360" cy="106959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/>
          </p:nvCxnSpPr>
          <p:spPr>
            <a:xfrm>
              <a:off x="2910710" y="1481623"/>
              <a:ext cx="575699" cy="77904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Connector 16"/>
            <p:cNvCxnSpPr/>
            <p:nvPr/>
          </p:nvCxnSpPr>
          <p:spPr>
            <a:xfrm>
              <a:off x="3471528" y="1551568"/>
              <a:ext cx="16608" cy="4182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/>
            <p:cNvCxnSpPr/>
            <p:nvPr/>
          </p:nvCxnSpPr>
          <p:spPr>
            <a:xfrm>
              <a:off x="2719783" y="1653946"/>
              <a:ext cx="394127" cy="30993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/>
            <p:cNvCxnSpPr/>
            <p:nvPr/>
          </p:nvCxnSpPr>
          <p:spPr>
            <a:xfrm flipV="1">
              <a:off x="2668343" y="1712698"/>
              <a:ext cx="382101" cy="53347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/>
            <p:cNvCxnSpPr/>
            <p:nvPr/>
          </p:nvCxnSpPr>
          <p:spPr>
            <a:xfrm>
              <a:off x="3046333" y="1705600"/>
              <a:ext cx="19691" cy="4182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/>
            <p:cNvCxnSpPr/>
            <p:nvPr/>
          </p:nvCxnSpPr>
          <p:spPr>
            <a:xfrm>
              <a:off x="2826657" y="1844147"/>
              <a:ext cx="19691" cy="4182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21"/>
            <p:cNvCxnSpPr/>
            <p:nvPr/>
          </p:nvCxnSpPr>
          <p:spPr>
            <a:xfrm flipV="1">
              <a:off x="2385711" y="1848543"/>
              <a:ext cx="449312" cy="107623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/>
            <p:cNvCxnSpPr/>
            <p:nvPr/>
          </p:nvCxnSpPr>
          <p:spPr>
            <a:xfrm>
              <a:off x="3979219" y="1455934"/>
              <a:ext cx="0" cy="6333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/>
            <p:cNvCxnSpPr/>
            <p:nvPr/>
          </p:nvCxnSpPr>
          <p:spPr>
            <a:xfrm>
              <a:off x="4051168" y="1469014"/>
              <a:ext cx="0" cy="6333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Connector 24"/>
            <p:cNvCxnSpPr/>
            <p:nvPr/>
          </p:nvCxnSpPr>
          <p:spPr>
            <a:xfrm flipV="1">
              <a:off x="4050047" y="1407188"/>
              <a:ext cx="287360" cy="6327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Connector 25"/>
            <p:cNvCxnSpPr/>
            <p:nvPr/>
          </p:nvCxnSpPr>
          <p:spPr>
            <a:xfrm flipV="1">
              <a:off x="3977210" y="1323189"/>
              <a:ext cx="114803" cy="132747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TextBox 26"/>
            <p:cNvSpPr txBox="1"/>
            <p:nvPr/>
          </p:nvSpPr>
          <p:spPr>
            <a:xfrm>
              <a:off x="4222807" y="1249452"/>
              <a:ext cx="29367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700" dirty="0">
                  <a:latin typeface="Arial" panose="020B0604020202020204" pitchFamily="34" charset="0"/>
                  <a:cs typeface="Arial" panose="020B0604020202020204" pitchFamily="34" charset="0"/>
                </a:rPr>
                <a:t>LB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3894198" y="1116956"/>
              <a:ext cx="30809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700" dirty="0">
                  <a:latin typeface="Arial" panose="020B0604020202020204" pitchFamily="34" charset="0"/>
                  <a:cs typeface="Arial" panose="020B0604020202020204" pitchFamily="34" charset="0"/>
                </a:rPr>
                <a:t>RB</a:t>
              </a:r>
            </a:p>
          </p:txBody>
        </p:sp>
        <p:sp>
          <p:nvSpPr>
            <p:cNvPr id="29" name="Rounded Rectangle 28"/>
            <p:cNvSpPr/>
            <p:nvPr/>
          </p:nvSpPr>
          <p:spPr>
            <a:xfrm>
              <a:off x="5856164" y="4245223"/>
              <a:ext cx="333461" cy="395965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>
                <a:ln>
                  <a:solidFill>
                    <a:schemeClr val="bg1"/>
                  </a:solidFill>
                </a:ln>
                <a:solidFill>
                  <a:schemeClr val="bg1"/>
                </a:solidFill>
              </a:endParaRPr>
            </a:p>
          </p:txBody>
        </p:sp>
        <p:cxnSp>
          <p:nvCxnSpPr>
            <p:cNvPr id="30" name="Straight Connector 29"/>
            <p:cNvCxnSpPr/>
            <p:nvPr/>
          </p:nvCxnSpPr>
          <p:spPr>
            <a:xfrm>
              <a:off x="5726449" y="4284462"/>
              <a:ext cx="112069" cy="5860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TextBox 30"/>
            <p:cNvSpPr txBox="1"/>
            <p:nvPr/>
          </p:nvSpPr>
          <p:spPr>
            <a:xfrm rot="18366201">
              <a:off x="5565792" y="4235773"/>
              <a:ext cx="72968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700" dirty="0">
                  <a:latin typeface="Arial" panose="020B0604020202020204" pitchFamily="34" charset="0"/>
                  <a:cs typeface="Arial" panose="020B0604020202020204" pitchFamily="34" charset="0"/>
                </a:rPr>
                <a:t>35S promoter</a:t>
              </a:r>
            </a:p>
          </p:txBody>
        </p:sp>
        <p:cxnSp>
          <p:nvCxnSpPr>
            <p:cNvPr id="32" name="Straight Connector 31"/>
            <p:cNvCxnSpPr/>
            <p:nvPr/>
          </p:nvCxnSpPr>
          <p:spPr>
            <a:xfrm>
              <a:off x="2319160" y="2166219"/>
              <a:ext cx="150951" cy="19415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Rectangle 32"/>
            <p:cNvSpPr/>
            <p:nvPr/>
          </p:nvSpPr>
          <p:spPr>
            <a:xfrm>
              <a:off x="2539891" y="3183346"/>
              <a:ext cx="2942231" cy="36503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3016016" y="3164401"/>
              <a:ext cx="2151995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CAMBIA</a:t>
              </a:r>
              <a:r>
                <a:rPr lang="en-CA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1302 carrying Cas9 and two </a:t>
              </a:r>
              <a:r>
                <a:rPr lang="en-CA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gRNA</a:t>
              </a:r>
              <a:r>
                <a:rPr lang="en-CA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targeting </a:t>
              </a:r>
              <a:r>
                <a:rPr lang="en-CA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TaNFXL1</a:t>
              </a:r>
            </a:p>
            <a:p>
              <a:r>
                <a:rPr lang="en-CA" sz="1000" dirty="0"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                8804 </a:t>
              </a:r>
              <a:r>
                <a:rPr lang="en-CA" sz="1000" dirty="0" err="1"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bp</a:t>
              </a:r>
              <a:endParaRPr lang="en-CA" sz="1000" dirty="0"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4" name="Straight Connector 3"/>
          <p:cNvCxnSpPr/>
          <p:nvPr/>
        </p:nvCxnSpPr>
        <p:spPr>
          <a:xfrm>
            <a:off x="2748942" y="2122111"/>
            <a:ext cx="70603" cy="6352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/>
          <p:cNvCxnSpPr/>
          <p:nvPr/>
        </p:nvCxnSpPr>
        <p:spPr>
          <a:xfrm>
            <a:off x="3894707" y="1615765"/>
            <a:ext cx="15056" cy="13286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2755665" y="2095487"/>
            <a:ext cx="42832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coRI</a:t>
            </a:r>
            <a:endParaRPr lang="en-CA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3744494" y="1700094"/>
            <a:ext cx="36901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pnI</a:t>
            </a:r>
            <a:endParaRPr lang="en-CA" sz="7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" name="Straight Connector 43"/>
          <p:cNvCxnSpPr/>
          <p:nvPr/>
        </p:nvCxnSpPr>
        <p:spPr>
          <a:xfrm>
            <a:off x="3941440" y="1615765"/>
            <a:ext cx="15056" cy="13286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2189947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7</TotalTime>
  <Words>32</Words>
  <Application>Microsoft Office PowerPoint</Application>
  <PresentationFormat>On-screen Show (4:3)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ahoma</vt:lpstr>
      <vt:lpstr>Office Theme</vt:lpstr>
      <vt:lpstr>PowerPoint Presentation</vt:lpstr>
    </vt:vector>
  </TitlesOfParts>
  <Company>AAFC-AA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bramaniam, Gopal</dc:creator>
  <cp:lastModifiedBy>Ouellet, Thérèse</cp:lastModifiedBy>
  <cp:revision>7</cp:revision>
  <dcterms:created xsi:type="dcterms:W3CDTF">2019-05-09T14:15:43Z</dcterms:created>
  <dcterms:modified xsi:type="dcterms:W3CDTF">2019-06-14T15:44:58Z</dcterms:modified>
</cp:coreProperties>
</file>